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4A477-EA55-E0B3-08CC-4CD66E157C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B1B398-503C-863B-5EB2-1F348CBF3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5661EC-CF4C-0382-1A66-ACEE973D6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86A9B8-081D-F583-A8F8-6C5DFE168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26E72-F7C1-C632-DFCC-4ECEFA02F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38643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660A2A-E1F0-8D4D-BA28-A109453B8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7C8B83-6A6E-F572-99C1-F8AC60A5F1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A956ED-41AF-B05E-BB08-9B0A280C3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FB424A-7E19-862A-1461-89644F437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CACD43-1B3E-ADB7-EB5F-CA17687EA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36220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10387E-E89C-7BD4-CC81-B032993DF7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B89CFB-1D0B-7AA1-F429-D30B61DD7B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1981D-7194-C3C7-EDDA-4EC2ED8EB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9E226A-8A79-D772-C625-6E427D30A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E2AF9-CE72-B5B7-5AB0-36427437D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82373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8565A-1F72-3062-A6F1-F6A8E661D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3BA074-12ED-5858-7D29-50452350FC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DE3C45-3913-346D-C132-3CAFF1DDE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9C10A3-0F27-F0C7-8A54-F2DBEC795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9ECBC9-95B6-E4BF-7867-567A91E53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06145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7CE975-2B2D-82B2-2336-A64F1AFC9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965DD0-F825-01BA-3F13-E69EDCFC56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762A0D-3E50-431C-6E7B-F50CFABB5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32BFC-0BBF-D065-C0D9-77EB4F564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B755AE-BE1F-30E4-7150-7C2834E7C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24309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29A296-F337-9B01-9B15-D03D6606A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26037A-CE47-6ED0-3F8C-9255BE3647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F121F4-A0FC-3C54-C1B6-D3FBAA8D3E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4CAC08-D762-A4B0-256A-618E3A3D2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744EF8-93C1-9EC3-F7FC-9F3469A50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AFA491-4582-A5B4-9498-BB78C1FF5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01081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B753F5-62B2-D179-9E75-B7CDB382B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0C5F56-8A15-DCCF-145B-03106CFBFC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6755E7-BCBD-D888-9E42-1E0FE06358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3E287A-4833-3543-8308-5797B7BA66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455100-0C1F-4E5B-8B55-15C8068CD8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5F0440E-8674-8CD8-5B63-C98D735D4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8A881C-F6A5-FB2F-3C57-FDA578D5C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7C3620-3961-A843-E97F-12D3E4F5F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5658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AFBE86-6670-6FF4-0DFF-179D5513D4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4D5F62-A082-7E73-0266-CAD9132A4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5B996D-DFDA-38E0-F854-7F0174D05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D37947-E45E-40B6-14DF-902FC674C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38271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6235CC-0751-AC51-43D4-A49F81DB6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5DBE0F-9F5F-643D-28DF-3A456EDFD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B3F2D9-CF20-4AE8-C1AE-0120A7330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04969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ADC4D2-79C4-AEDA-AF22-32B699E59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1EEE43-0CDF-7B41-7467-572E771EE2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5CDF96-DE9D-75F1-3B99-9375748F03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AEC992-0EE4-7B80-7BE4-24FC8637B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CB753C-5123-D926-7111-36243F46E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39D940-E750-C6B0-DC7B-106E2A904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2055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0E069-839C-E938-E6A6-65468A9DF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DCD3811-4A9A-8990-E5F8-305A0A2FC3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01AECB-ED80-FBE4-953A-988C758B60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8A05E6-F370-82C1-2B58-4A1070B59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11ACEB-459C-62FF-E760-7B310384B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63D052-1A66-9302-F71A-BF24B4ED2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26513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A0D861-7497-25E1-2FDB-86406F098D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B65702-4EFB-82CE-7F2B-B74E9D58B5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3586F6-21D4-FEAD-24F1-5AE4D0DFE4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C87DA-E39E-40F1-AA68-9E4AEA94B99A}" type="datetimeFigureOut">
              <a:rPr lang="en-ZA" smtClean="0"/>
              <a:t>2022/10/1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041AD-ED7D-7F21-4B13-D040FE3796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EAC08-6C35-62DB-1C6F-6ECBB0EA22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29FD9-3CFB-42AC-AE08-EC72926B2A6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29570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lbertsh@cput.ac.za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EDF1395-58C0-003F-91E0-49603C2C0740}"/>
              </a:ext>
            </a:extLst>
          </p:cNvPr>
          <p:cNvSpPr txBox="1"/>
          <p:nvPr/>
        </p:nvSpPr>
        <p:spPr>
          <a:xfrm>
            <a:off x="717005" y="337625"/>
            <a:ext cx="10959179" cy="6253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A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rrent Microbiology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A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A" sz="16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ycological and Multiple Mycotoxin Surveillance of Sorghum and Pearl Millet Produced by Smallholder Farmers in Namibia 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vin R. Kaela</a:t>
            </a:r>
            <a:r>
              <a:rPr lang="en-US" sz="16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iska Lilly</a:t>
            </a:r>
            <a:r>
              <a:rPr lang="en-US" sz="16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ohn P. Rheeder</a:t>
            </a:r>
            <a:r>
              <a:rPr lang="en-US" sz="16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ane M. Misihairabgwi</a:t>
            </a:r>
            <a:r>
              <a:rPr lang="en-US" sz="16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Johanna F. Alberts</a:t>
            </a:r>
            <a:r>
              <a:rPr lang="en-US" sz="16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Agriculture,</a:t>
            </a:r>
            <a:r>
              <a:rPr lang="en-ZW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pe Peninsula University of Technology, </a:t>
            </a:r>
            <a:r>
              <a:rPr lang="en-ZW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vate Bag X8, Wellington, South Africa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W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plied Microbial and Health Biotechnology Institute (AMHBI), Cape Peninsula University of Technology, PO Box 1906, Bellville, South Africa.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W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technology and Consumer Sciences, Cape Peninsula University of Technology, PO Box 1906, Bellville, South Africa.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ZW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chemistry and Microbiology, School of Medicine, University of Namibia, PO Box 13301, Windhoek, Namibia. 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W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Food Science and Technology, Cape Peninsula University of Technology, PO Box 1906, Bellville, South Africa.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W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Z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Johanna F. Alberts; E-mail </a:t>
            </a:r>
            <a:r>
              <a:rPr lang="en-US" sz="16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albertsh@cput.ac.z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Tel. no. +27 219596236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ectronic Supplementary Material Figs. S1, S2.</a:t>
            </a:r>
            <a:endParaRPr lang="en-ZA" sz="16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647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people walking on a dirt road&#10;&#10;Description automatically generated with medium confidence">
            <a:extLst>
              <a:ext uri="{FF2B5EF4-FFF2-40B4-BE49-F238E27FC236}">
                <a16:creationId xmlns:a16="http://schemas.microsoft.com/office/drawing/2014/main" id="{7AA454BC-B7B1-BF66-4478-832DBF7799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9469" y="731519"/>
            <a:ext cx="6067865" cy="45508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FEC963B-65EE-6060-2F51-7167692C3276}"/>
              </a:ext>
            </a:extLst>
          </p:cNvPr>
          <p:cNvSpPr txBox="1"/>
          <p:nvPr/>
        </p:nvSpPr>
        <p:spPr>
          <a:xfrm>
            <a:off x="2349818" y="5479367"/>
            <a:ext cx="74923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traditional threshing floor used by smallholder farmers in the Oshana region of Namibia (Photo credit: Dr JP Rheeder)</a:t>
            </a:r>
            <a:endParaRPr lang="en-Z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743455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few bales of hay&#10;&#10;Description automatically generated with low confidence">
            <a:extLst>
              <a:ext uri="{FF2B5EF4-FFF2-40B4-BE49-F238E27FC236}">
                <a16:creationId xmlns:a16="http://schemas.microsoft.com/office/drawing/2014/main" id="{2F29678F-F8DF-DEFA-6A10-88E0C12363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553" y="791308"/>
            <a:ext cx="5406683" cy="40550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E1FE4FF-CB25-5899-076B-FDE1F33368DD}"/>
              </a:ext>
            </a:extLst>
          </p:cNvPr>
          <p:cNvSpPr txBox="1"/>
          <p:nvPr/>
        </p:nvSpPr>
        <p:spPr>
          <a:xfrm>
            <a:off x="2386866" y="5143362"/>
            <a:ext cx="70764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traditional storage basket used by smallholder farmers in the Oshana region of Namibia (Photo credit: Dr JP Rheeder)</a:t>
            </a:r>
            <a:endParaRPr lang="en-Z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374398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39</Words>
  <Application>Microsoft Office PowerPoint</Application>
  <PresentationFormat>Widescreen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eke Alberts</dc:creator>
  <cp:lastModifiedBy>Hanneke Alberts</cp:lastModifiedBy>
  <cp:revision>1</cp:revision>
  <dcterms:created xsi:type="dcterms:W3CDTF">2022-10-19T18:58:55Z</dcterms:created>
  <dcterms:modified xsi:type="dcterms:W3CDTF">2022-10-19T19:06:37Z</dcterms:modified>
</cp:coreProperties>
</file>